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88888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128" y="8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776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371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4356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2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355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4813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845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979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4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7872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560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6016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84668" y="64067"/>
            <a:ext cx="44873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3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NanoString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differential expression output data for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35459" y="6584256"/>
            <a:ext cx="29792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nBAP1+  vs  nBAP1-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 descr="Screen Clippi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713" y="399480"/>
            <a:ext cx="4442328" cy="61732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Screen Clippi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5852" y="399480"/>
            <a:ext cx="4596373" cy="617328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118535" y="6579456"/>
            <a:ext cx="28702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All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vs Control Liver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780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9</TotalTime>
  <Words>24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ini Krishna</dc:creator>
  <cp:lastModifiedBy>yamini krishna</cp:lastModifiedBy>
  <cp:revision>130</cp:revision>
  <dcterms:created xsi:type="dcterms:W3CDTF">2019-12-08T09:57:48Z</dcterms:created>
  <dcterms:modified xsi:type="dcterms:W3CDTF">2020-09-17T06:24:33Z</dcterms:modified>
</cp:coreProperties>
</file>